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81" r:id="rId2"/>
  </p:sldIdLst>
  <p:sldSz cx="6858000" cy="9906000" type="A4"/>
  <p:notesSz cx="6800850" cy="99329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F00D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  <p:ext uri="{1BD7E111-0CB8-44D6-8891-C1BB2F81B7CC}">
      <p1710:readonlyRecommended xmlns:p1710="http://schemas.microsoft.com/office/powerpoint/2017/10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5381" autoAdjust="0"/>
    <p:restoredTop sz="95865" autoAdjust="0"/>
  </p:normalViewPr>
  <p:slideViewPr>
    <p:cSldViewPr snapToGrid="0">
      <p:cViewPr varScale="1">
        <p:scale>
          <a:sx n="66" d="100"/>
          <a:sy n="66" d="100"/>
        </p:scale>
        <p:origin x="2875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7623" cy="498647"/>
          </a:xfrm>
          <a:prstGeom prst="rect">
            <a:avLst/>
          </a:prstGeom>
        </p:spPr>
        <p:txBody>
          <a:bodyPr vert="horz" lIns="92162" tIns="46081" rIns="92162" bIns="46081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1625" y="0"/>
            <a:ext cx="2947622" cy="498647"/>
          </a:xfrm>
          <a:prstGeom prst="rect">
            <a:avLst/>
          </a:prstGeom>
        </p:spPr>
        <p:txBody>
          <a:bodyPr vert="horz" lIns="92162" tIns="46081" rIns="92162" bIns="46081" rtlCol="0"/>
          <a:lstStyle>
            <a:lvl1pPr algn="r">
              <a:defRPr sz="1200"/>
            </a:lvl1pPr>
          </a:lstStyle>
          <a:p>
            <a:fld id="{D9D91BB7-6D9D-4300-9488-FE6F0B011AF5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20925" cy="335121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162" tIns="46081" rIns="92162" bIns="46081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605" y="4780300"/>
            <a:ext cx="5441642" cy="3910864"/>
          </a:xfrm>
          <a:prstGeom prst="rect">
            <a:avLst/>
          </a:prstGeom>
        </p:spPr>
        <p:txBody>
          <a:bodyPr vert="horz" lIns="92162" tIns="46081" rIns="92162" bIns="46081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1" y="9434341"/>
            <a:ext cx="2947623" cy="498647"/>
          </a:xfrm>
          <a:prstGeom prst="rect">
            <a:avLst/>
          </a:prstGeom>
        </p:spPr>
        <p:txBody>
          <a:bodyPr vert="horz" lIns="92162" tIns="46081" rIns="92162" bIns="46081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1625" y="9434341"/>
            <a:ext cx="2947622" cy="498647"/>
          </a:xfrm>
          <a:prstGeom prst="rect">
            <a:avLst/>
          </a:prstGeom>
        </p:spPr>
        <p:txBody>
          <a:bodyPr vert="horz" lIns="92162" tIns="46081" rIns="92162" bIns="46081" rtlCol="0" anchor="b"/>
          <a:lstStyle>
            <a:lvl1pPr algn="r">
              <a:defRPr sz="1200"/>
            </a:lvl1pPr>
          </a:lstStyle>
          <a:p>
            <a:fld id="{1454848C-FEA4-4A2B-87C2-C604F6929D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65039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39865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09747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21689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47384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12066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44366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68680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39160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24212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88540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34375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3120F0-1B69-4C06-880B-C0DF36F697EE}" type="datetimeFigureOut">
              <a:rPr kumimoji="1" lang="ja-JP" altLang="en-US" smtClean="0"/>
              <a:t>2025/9/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726F40-02E4-4AD1-B00C-B67344B9AA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45018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表 7">
            <a:extLst>
              <a:ext uri="{FF2B5EF4-FFF2-40B4-BE49-F238E27FC236}">
                <a16:creationId xmlns:a16="http://schemas.microsoft.com/office/drawing/2014/main" id="{E8F53816-67A0-272F-6C44-B7CA7B4166F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70899911"/>
              </p:ext>
            </p:extLst>
          </p:nvPr>
        </p:nvGraphicFramePr>
        <p:xfrm>
          <a:off x="50800" y="759768"/>
          <a:ext cx="6751322" cy="3046940"/>
        </p:xfrm>
        <a:graphic>
          <a:graphicData uri="http://schemas.openxmlformats.org/drawingml/2006/table">
            <a:tbl>
              <a:tblPr/>
              <a:tblGrid>
                <a:gridCol w="1718012">
                  <a:extLst>
                    <a:ext uri="{9D8B030D-6E8A-4147-A177-3AD203B41FA5}">
                      <a16:colId xmlns:a16="http://schemas.microsoft.com/office/drawing/2014/main" val="108865157"/>
                    </a:ext>
                  </a:extLst>
                </a:gridCol>
                <a:gridCol w="956516">
                  <a:extLst>
                    <a:ext uri="{9D8B030D-6E8A-4147-A177-3AD203B41FA5}">
                      <a16:colId xmlns:a16="http://schemas.microsoft.com/office/drawing/2014/main" val="2290767298"/>
                    </a:ext>
                  </a:extLst>
                </a:gridCol>
                <a:gridCol w="928653">
                  <a:extLst>
                    <a:ext uri="{9D8B030D-6E8A-4147-A177-3AD203B41FA5}">
                      <a16:colId xmlns:a16="http://schemas.microsoft.com/office/drawing/2014/main" val="993724674"/>
                    </a:ext>
                  </a:extLst>
                </a:gridCol>
                <a:gridCol w="492187">
                  <a:extLst>
                    <a:ext uri="{9D8B030D-6E8A-4147-A177-3AD203B41FA5}">
                      <a16:colId xmlns:a16="http://schemas.microsoft.com/office/drawing/2014/main" val="1294001342"/>
                    </a:ext>
                  </a:extLst>
                </a:gridCol>
                <a:gridCol w="334392">
                  <a:extLst>
                    <a:ext uri="{9D8B030D-6E8A-4147-A177-3AD203B41FA5}">
                      <a16:colId xmlns:a16="http://schemas.microsoft.com/office/drawing/2014/main" val="1769058851"/>
                    </a:ext>
                  </a:extLst>
                </a:gridCol>
                <a:gridCol w="993585">
                  <a:extLst>
                    <a:ext uri="{9D8B030D-6E8A-4147-A177-3AD203B41FA5}">
                      <a16:colId xmlns:a16="http://schemas.microsoft.com/office/drawing/2014/main" val="3390921449"/>
                    </a:ext>
                  </a:extLst>
                </a:gridCol>
                <a:gridCol w="835790">
                  <a:extLst>
                    <a:ext uri="{9D8B030D-6E8A-4147-A177-3AD203B41FA5}">
                      <a16:colId xmlns:a16="http://schemas.microsoft.com/office/drawing/2014/main" val="503713339"/>
                    </a:ext>
                  </a:extLst>
                </a:gridCol>
                <a:gridCol w="492187">
                  <a:extLst>
                    <a:ext uri="{9D8B030D-6E8A-4147-A177-3AD203B41FA5}">
                      <a16:colId xmlns:a16="http://schemas.microsoft.com/office/drawing/2014/main" val="4017886565"/>
                    </a:ext>
                  </a:extLst>
                </a:gridCol>
              </a:tblGrid>
              <a:tr h="146452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ja-JP" alt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 gridSpan="7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High-fat diet 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85726144"/>
                  </a:ext>
                </a:extLst>
              </a:tr>
              <a:tr h="146452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male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r>
                        <a:rPr lang="ja-JP" alt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3"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female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35758211"/>
                  </a:ext>
                </a:extLst>
              </a:tr>
              <a:tr h="146452">
                <a:tc>
                  <a:txBody>
                    <a:bodyPr/>
                    <a:lstStyle/>
                    <a:p>
                      <a:pPr algn="l" fontAlgn="ctr">
                        <a:buNone/>
                      </a:pPr>
                      <a:endParaRPr lang="ja-JP" alt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fl/fl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VeNKO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value 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ja-JP" alt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fl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/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fl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VeNKO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value 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75605884"/>
                  </a:ext>
                </a:extLst>
              </a:tr>
              <a:tr h="317312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Vascular Endothelial NAD</a:t>
                      </a:r>
                      <a:r>
                        <a:rPr lang="en-US" altLang="ja-JP" sz="8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+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ＭＳ Ｐゴシック" panose="020B0600070205080204" pitchFamily="50" charset="-128"/>
                          <a:ea typeface="ＭＳ Ｐゴシック" panose="020B0600070205080204" pitchFamily="50" charset="-128"/>
                        </a:rPr>
                        <a:t>　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    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ＭＳ Ｐゴシック" panose="020B0600070205080204" pitchFamily="50" charset="-128"/>
                          <a:ea typeface="ＭＳ Ｐゴシック" panose="020B0600070205080204" pitchFamily="50" charset="-128"/>
                        </a:rPr>
                        <a:t>　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mole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/µg-protein)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8.462 ± 1.294</a:t>
                      </a:r>
                      <a:b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= 5)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5.117 ± 0.423</a:t>
                      </a:r>
                      <a:b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</a:t>
                      </a:r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= 5)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0394</a:t>
                      </a:r>
                      <a:r>
                        <a:rPr lang="ja-JP" altLang="en-US" sz="800" b="0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＊</a:t>
                      </a:r>
                      <a:endParaRPr lang="en-US" altLang="ja-JP" sz="800" b="0" i="0" u="none" strike="noStrike" baseline="30000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8.488 ± 0.558</a:t>
                      </a:r>
                      <a:b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= 5)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4.283 ± 0.389</a:t>
                      </a:r>
                      <a:b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= 8)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&lt;0.01</a:t>
                      </a:r>
                      <a:r>
                        <a:rPr lang="en-US" altLang="ja-JP" sz="80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**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32706514"/>
                  </a:ext>
                </a:extLst>
              </a:tr>
              <a:tr h="317312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Food intake </a:t>
                      </a:r>
                      <a:r>
                        <a:rPr lang="ja-JP" alt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　　　　　　　　　　　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g</a:t>
                      </a: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/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g-body weight</a:t>
                      </a: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/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day)  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1031 ± 0.0045</a:t>
                      </a:r>
                      <a:b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(</a:t>
                      </a:r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= 10)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1063 ± 0.0071</a:t>
                      </a:r>
                      <a:b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(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= 6)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94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1321 ± 0.0092 </a:t>
                      </a:r>
                      <a:r>
                        <a:rPr lang="ja-JP" alt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= 4)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1227 ± 0.0059 (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= 6)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3899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11479650"/>
                  </a:ext>
                </a:extLst>
              </a:tr>
              <a:tr h="317312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IPGTT                                             AUC Glucose </a:t>
                      </a:r>
                      <a:r>
                        <a:rPr lang="en-US" sz="8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0–120) 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mg/dL*min)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44229 ± 3873</a:t>
                      </a:r>
                      <a:b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= 10)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47401 ± 2176</a:t>
                      </a:r>
                      <a:b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</a:t>
                      </a:r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= 8)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15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42416 ± 3883</a:t>
                      </a:r>
                      <a:b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</a:t>
                      </a:r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= 11)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44483 ± 4468</a:t>
                      </a:r>
                      <a:b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 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= 7)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737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65399723"/>
                  </a:ext>
                </a:extLst>
              </a:tr>
              <a:tr h="386400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Insulin (pg/mL)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40.09 ± 56.38         (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= 7)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6</a:t>
                      </a: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55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.45 ± 82.01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= </a:t>
                      </a: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4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) 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&lt;0.01</a:t>
                      </a:r>
                      <a:r>
                        <a:rPr lang="en-US" altLang="ja-JP" sz="80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**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  <a:cs typeface="Arial" panose="020B0604020202020204" pitchFamily="34" charset="0"/>
                      </a:endParaRP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ja-JP" alt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239.32 ± 45.78 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= 5)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308.54 ± 64.93</a:t>
                      </a:r>
                    </a:p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= 4)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418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55864664"/>
                  </a:ext>
                </a:extLst>
              </a:tr>
              <a:tr h="317312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SBP (mmHg)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07.6 ± 4.8</a:t>
                      </a:r>
                      <a:b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= 6)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34.0 ± 6.3</a:t>
                      </a:r>
                      <a:b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</a:t>
                      </a:r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= 5)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&lt;0.01</a:t>
                      </a:r>
                      <a:r>
                        <a:rPr lang="en-US" altLang="ja-JP" sz="80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*</a:t>
                      </a:r>
                      <a:r>
                        <a:rPr lang="en-US" altLang="ja-JP" sz="800" i="1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*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20.7 ± 5.5</a:t>
                      </a:r>
                      <a:b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= 8)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127.2 ± 5.8</a:t>
                      </a:r>
                      <a:b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= 7)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428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43529190"/>
                  </a:ext>
                </a:extLst>
              </a:tr>
              <a:tr h="317312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DBP (mmHg)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56.13 ± 3.21</a:t>
                      </a:r>
                      <a:b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</a:t>
                      </a:r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= 6)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74.26 ± 7.87</a:t>
                      </a:r>
                      <a:b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= 5)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0483</a:t>
                      </a:r>
                      <a:r>
                        <a:rPr lang="en-US" altLang="ja-JP" sz="80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*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65.62 ± 3.50</a:t>
                      </a:r>
                      <a:b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= 8)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65.93 ± 6.86</a:t>
                      </a:r>
                      <a:b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= 7)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967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01467790"/>
                  </a:ext>
                </a:extLst>
              </a:tr>
              <a:tr h="317312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ardia mass</a:t>
                      </a:r>
                      <a:r>
                        <a:rPr lang="ja-JP" alt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　　　　　　　　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(mg/g-body weight)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4.989 ± 0.208</a:t>
                      </a:r>
                      <a:b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</a:t>
                      </a:r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</a:t>
                      </a: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= 12)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6.111 ± 0.377</a:t>
                      </a:r>
                      <a:b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= 7)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011</a:t>
                      </a:r>
                      <a:r>
                        <a:rPr lang="en-US" altLang="ja-JP" sz="80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*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ja-JP" alt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4.824 ± 0.173</a:t>
                      </a:r>
                      <a:b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= 11)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5.034 ± 0.346</a:t>
                      </a:r>
                      <a:b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= 7)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56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41305175"/>
                  </a:ext>
                </a:extLst>
              </a:tr>
              <a:tr h="317312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Media thickness/Lumen diameter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09262 ± 0.00179</a:t>
                      </a:r>
                      <a:b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 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= 4)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09909 ± 0.00013</a:t>
                      </a:r>
                      <a:b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= 3)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0283</a:t>
                      </a:r>
                      <a:r>
                        <a:rPr lang="en-US" altLang="ja-JP" sz="800" i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明朝" panose="02020400000000000000" pitchFamily="18" charset="-128"/>
                          <a:cs typeface="Arial" panose="020B0604020202020204" pitchFamily="34" charset="0"/>
                        </a:rPr>
                        <a:t>*</a:t>
                      </a:r>
                      <a:endParaRPr lang="en-US" altLang="ja-JP" sz="8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ja-JP" alt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0990 ± 0.0025</a:t>
                      </a:r>
                      <a:b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 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= 5)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0957 ± 0.0063</a:t>
                      </a:r>
                      <a:b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</a:b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(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= 5)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46</a:t>
                      </a:r>
                    </a:p>
                  </a:txBody>
                  <a:tcPr marL="4882" marR="4882" marT="488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12708281"/>
                  </a:ext>
                </a:extLst>
              </a:tr>
            </a:tbl>
          </a:graphicData>
        </a:graphic>
      </p:graphicFrame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38717B64-C888-BEC8-8088-14ED30988166}"/>
              </a:ext>
            </a:extLst>
          </p:cNvPr>
          <p:cNvSpPr txBox="1"/>
          <p:nvPr/>
        </p:nvSpPr>
        <p:spPr>
          <a:xfrm>
            <a:off x="3297904" y="64583"/>
            <a:ext cx="388521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kumimoji="1" lang="ja-JP" alt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Table 1</a:t>
            </a:r>
            <a:endParaRPr kumimoji="1" lang="ja-JP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B3A2F5CF-0726-DB04-4D21-B964E1924F91}"/>
              </a:ext>
            </a:extLst>
          </p:cNvPr>
          <p:cNvSpPr txBox="1"/>
          <p:nvPr/>
        </p:nvSpPr>
        <p:spPr>
          <a:xfrm>
            <a:off x="322580" y="3872915"/>
            <a:ext cx="665734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8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IPGTT; intraperitoneal glucose tolerance test, AUC; area under the curve, SBP; </a:t>
            </a:r>
            <a:r>
              <a:rPr lang="en-US" altLang="ja-JP" sz="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ystolic </a:t>
            </a:r>
            <a:r>
              <a:rPr lang="en-US" altLang="ja-JP" sz="8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blood pressure, DBP; </a:t>
            </a:r>
            <a:r>
              <a:rPr lang="en-US" altLang="ja-JP" sz="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diastolic blood pressure</a:t>
            </a:r>
            <a:r>
              <a:rPr lang="en-US" altLang="ja-JP" sz="8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.</a:t>
            </a:r>
          </a:p>
          <a:p>
            <a:r>
              <a:rPr lang="en-US" altLang="ja-JP" sz="8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Data were analyzed using Student’s unpaired </a:t>
            </a:r>
            <a:r>
              <a:rPr lang="en-US" altLang="ja-JP" sz="800" i="1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</a:t>
            </a:r>
            <a:r>
              <a:rPr lang="en-US" altLang="ja-JP" sz="8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-test.</a:t>
            </a:r>
            <a:r>
              <a:rPr lang="ja-JP" altLang="en-US" sz="8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8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ll values are presented as the mean ± SEM.</a:t>
            </a:r>
            <a:r>
              <a:rPr lang="ja-JP" altLang="en-US" sz="800" dirty="0">
                <a:solidFill>
                  <a:srgbClr val="000000"/>
                </a:solidFill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8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*p &lt; </a:t>
            </a:r>
            <a:r>
              <a:rPr lang="en-US" altLang="ja-JP" sz="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0.05</a:t>
            </a:r>
            <a:r>
              <a:rPr lang="en-US" altLang="ja-JP" sz="8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, </a:t>
            </a:r>
            <a:r>
              <a:rPr lang="en-US" altLang="ja-JP" sz="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**</a:t>
            </a:r>
            <a:r>
              <a:rPr lang="en-US" altLang="ja-JP" sz="8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 </a:t>
            </a:r>
            <a:r>
              <a:rPr lang="en-US" altLang="ja-JP" sz="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&lt; 0.01.</a:t>
            </a:r>
            <a:endParaRPr lang="en-US" altLang="ja-JP" sz="800" dirty="0">
              <a:solidFill>
                <a:srgbClr val="000000"/>
              </a:solidFill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r>
              <a:rPr lang="en-US" altLang="ja-JP" sz="800" b="1" dirty="0">
                <a:solidFill>
                  <a:srgbClr val="FF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endParaRPr lang="ja-JP" altLang="en-US" sz="8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080825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156</TotalTime>
  <Words>454</Words>
  <Application>Microsoft Office PowerPoint</Application>
  <PresentationFormat>A4 210 x 297 mm</PresentationFormat>
  <Paragraphs>8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ＭＳ Ｐゴシック</vt:lpstr>
      <vt:lpstr>游ゴシック</vt:lpstr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 Y</dc:creator>
  <cp:lastModifiedBy>yama1005@keio.jp</cp:lastModifiedBy>
  <cp:revision>511</cp:revision>
  <cp:lastPrinted>2025-08-07T09:30:53Z</cp:lastPrinted>
  <dcterms:created xsi:type="dcterms:W3CDTF">2020-05-07T06:16:48Z</dcterms:created>
  <dcterms:modified xsi:type="dcterms:W3CDTF">2025-09-05T14:07:52Z</dcterms:modified>
</cp:coreProperties>
</file>